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1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150" y="3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4044A-3B5B-4CC2-A77C-5F0C1B9A0F98}" type="datetimeFigureOut">
              <a:rPr lang="en-GB" smtClean="0"/>
              <a:t>08/08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DBF78-BBB1-4260-8530-475C764DC6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918237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4044A-3B5B-4CC2-A77C-5F0C1B9A0F98}" type="datetimeFigureOut">
              <a:rPr lang="en-GB" smtClean="0"/>
              <a:t>08/08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DBF78-BBB1-4260-8530-475C764DC6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715590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4044A-3B5B-4CC2-A77C-5F0C1B9A0F98}" type="datetimeFigureOut">
              <a:rPr lang="en-GB" smtClean="0"/>
              <a:t>08/08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DBF78-BBB1-4260-8530-475C764DC6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01108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4044A-3B5B-4CC2-A77C-5F0C1B9A0F98}" type="datetimeFigureOut">
              <a:rPr lang="en-GB" smtClean="0"/>
              <a:t>08/08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DBF78-BBB1-4260-8530-475C764DC6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84516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4044A-3B5B-4CC2-A77C-5F0C1B9A0F98}" type="datetimeFigureOut">
              <a:rPr lang="en-GB" smtClean="0"/>
              <a:t>08/08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DBF78-BBB1-4260-8530-475C764DC6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93457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4044A-3B5B-4CC2-A77C-5F0C1B9A0F98}" type="datetimeFigureOut">
              <a:rPr lang="en-GB" smtClean="0"/>
              <a:t>08/08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DBF78-BBB1-4260-8530-475C764DC6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968988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4044A-3B5B-4CC2-A77C-5F0C1B9A0F98}" type="datetimeFigureOut">
              <a:rPr lang="en-GB" smtClean="0"/>
              <a:t>08/08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DBF78-BBB1-4260-8530-475C764DC6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22142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4044A-3B5B-4CC2-A77C-5F0C1B9A0F98}" type="datetimeFigureOut">
              <a:rPr lang="en-GB" smtClean="0"/>
              <a:t>08/08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DBF78-BBB1-4260-8530-475C764DC6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21284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4044A-3B5B-4CC2-A77C-5F0C1B9A0F98}" type="datetimeFigureOut">
              <a:rPr lang="en-GB" smtClean="0"/>
              <a:t>08/08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DBF78-BBB1-4260-8530-475C764DC6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53843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4044A-3B5B-4CC2-A77C-5F0C1B9A0F98}" type="datetimeFigureOut">
              <a:rPr lang="en-GB" smtClean="0"/>
              <a:t>08/08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DBF78-BBB1-4260-8530-475C764DC6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97180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4044A-3B5B-4CC2-A77C-5F0C1B9A0F98}" type="datetimeFigureOut">
              <a:rPr lang="en-GB" smtClean="0"/>
              <a:t>08/08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ADBF78-BBB1-4260-8530-475C764DC6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04364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B4044A-3B5B-4CC2-A77C-5F0C1B9A0F98}" type="datetimeFigureOut">
              <a:rPr lang="en-GB" smtClean="0"/>
              <a:t>08/08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ADBF78-BBB1-4260-8530-475C764DC69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01293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8777" y="0"/>
            <a:ext cx="5126545" cy="68580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7972426" y="790575"/>
            <a:ext cx="340995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u="sng" dirty="0"/>
              <a:t>Additional File  6  </a:t>
            </a:r>
            <a:r>
              <a:rPr lang="en-GB" sz="1400" dirty="0"/>
              <a:t>Developmental changes in selected </a:t>
            </a:r>
            <a:r>
              <a:rPr lang="en-GB" sz="1400" dirty="0" err="1"/>
              <a:t>Sertoli</a:t>
            </a:r>
            <a:r>
              <a:rPr lang="en-GB" sz="1400" dirty="0"/>
              <a:t> cell-specific transcripts. Data shows mean ± SEM of 2-4 animals per group.</a:t>
            </a:r>
            <a:endParaRPr lang="en-GB" sz="1400" dirty="0"/>
          </a:p>
        </p:txBody>
      </p:sp>
    </p:spTree>
    <p:extLst>
      <p:ext uri="{BB962C8B-B14F-4D97-AF65-F5344CB8AC3E}">
        <p14:creationId xmlns:p14="http://schemas.microsoft.com/office/powerpoint/2010/main" val="26715575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ter O'Shaughnessy</dc:creator>
  <cp:lastModifiedBy>Peter O'Shaughnessy</cp:lastModifiedBy>
  <cp:revision>1</cp:revision>
  <dcterms:created xsi:type="dcterms:W3CDTF">2017-08-08T12:26:57Z</dcterms:created>
  <dcterms:modified xsi:type="dcterms:W3CDTF">2017-08-08T12:27:36Z</dcterms:modified>
</cp:coreProperties>
</file>